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68" r:id="rId3"/>
    <p:sldId id="277" r:id="rId4"/>
    <p:sldId id="257" r:id="rId5"/>
    <p:sldId id="259" r:id="rId6"/>
    <p:sldId id="262" r:id="rId7"/>
    <p:sldId id="263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tie Gray" initials="KG" lastIdx="9" clrIdx="0">
    <p:extLst>
      <p:ext uri="{19B8F6BF-5375-455C-9EA6-DF929625EA0E}">
        <p15:presenceInfo xmlns:p15="http://schemas.microsoft.com/office/powerpoint/2012/main" userId="S-1-5-21-1417001333-839522115-1801674531-27330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883" autoAdjust="0"/>
    <p:restoredTop sz="94660"/>
  </p:normalViewPr>
  <p:slideViewPr>
    <p:cSldViewPr snapToGrid="0">
      <p:cViewPr varScale="1">
        <p:scale>
          <a:sx n="57" d="100"/>
          <a:sy n="57" d="100"/>
        </p:scale>
        <p:origin x="90" y="12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EE51F-73F3-4190-9222-37CC6258A77A}" type="datetimeFigureOut">
              <a:rPr lang="en-GB" smtClean="0"/>
              <a:t>11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55BF5-4326-43BF-BD1A-353CB03319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61152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EE51F-73F3-4190-9222-37CC6258A77A}" type="datetimeFigureOut">
              <a:rPr lang="en-GB" smtClean="0"/>
              <a:t>11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55BF5-4326-43BF-BD1A-353CB03319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42201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EE51F-73F3-4190-9222-37CC6258A77A}" type="datetimeFigureOut">
              <a:rPr lang="en-GB" smtClean="0"/>
              <a:t>11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55BF5-4326-43BF-BD1A-353CB03319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53666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EE51F-73F3-4190-9222-37CC6258A77A}" type="datetimeFigureOut">
              <a:rPr lang="en-GB" smtClean="0"/>
              <a:t>11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55BF5-4326-43BF-BD1A-353CB03319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5545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EE51F-73F3-4190-9222-37CC6258A77A}" type="datetimeFigureOut">
              <a:rPr lang="en-GB" smtClean="0"/>
              <a:t>11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55BF5-4326-43BF-BD1A-353CB03319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55199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EE51F-73F3-4190-9222-37CC6258A77A}" type="datetimeFigureOut">
              <a:rPr lang="en-GB" smtClean="0"/>
              <a:t>11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55BF5-4326-43BF-BD1A-353CB03319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879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EE51F-73F3-4190-9222-37CC6258A77A}" type="datetimeFigureOut">
              <a:rPr lang="en-GB" smtClean="0"/>
              <a:t>11/06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55BF5-4326-43BF-BD1A-353CB03319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32740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EE51F-73F3-4190-9222-37CC6258A77A}" type="datetimeFigureOut">
              <a:rPr lang="en-GB" smtClean="0"/>
              <a:t>11/06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55BF5-4326-43BF-BD1A-353CB03319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37875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EE51F-73F3-4190-9222-37CC6258A77A}" type="datetimeFigureOut">
              <a:rPr lang="en-GB" smtClean="0"/>
              <a:t>11/06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55BF5-4326-43BF-BD1A-353CB03319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74832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EE51F-73F3-4190-9222-37CC6258A77A}" type="datetimeFigureOut">
              <a:rPr lang="en-GB" smtClean="0"/>
              <a:t>11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55BF5-4326-43BF-BD1A-353CB03319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24468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EE51F-73F3-4190-9222-37CC6258A77A}" type="datetimeFigureOut">
              <a:rPr lang="en-GB" smtClean="0"/>
              <a:t>11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55BF5-4326-43BF-BD1A-353CB03319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13210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6EE51F-73F3-4190-9222-37CC6258A77A}" type="datetimeFigureOut">
              <a:rPr lang="en-GB" smtClean="0"/>
              <a:t>11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155BF5-4326-43BF-BD1A-353CB033190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6989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76809" y="202631"/>
            <a:ext cx="119151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Table 1. List of locked nucleic acid primer-probe sets used for qPCR.</a:t>
            </a:r>
            <a:r>
              <a:rPr lang="en-US" sz="1400" dirty="0"/>
              <a:t> </a:t>
            </a:r>
            <a:r>
              <a:rPr lang="en-GB" sz="1400" dirty="0"/>
              <a:t>All Assay IDs refer to Exiqon products.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49134601"/>
              </p:ext>
            </p:extLst>
          </p:nvPr>
        </p:nvGraphicFramePr>
        <p:xfrm>
          <a:off x="4181475" y="1062387"/>
          <a:ext cx="3381375" cy="2200275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88427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497098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</a:rPr>
                        <a:t>Exiqon LNA primer-probes</a:t>
                      </a:r>
                      <a:endParaRPr lang="en-GB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</a:rPr>
                        <a:t>Assay IDs</a:t>
                      </a:r>
                      <a:endParaRPr lang="en-GB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SNORD48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20390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let-7c-5p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204767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hsa-miR-21-3p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20430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hsa-miR-23b-3p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204790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hsa-miR-34a-3p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204318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hsa-miR-34a-5p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204486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hsa-miR-103a-3p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20406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hsa-miR-142-3p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204291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hsa-miR-365a-3p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20462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hsa-miR-503-5p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204334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581008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16191" y="202632"/>
            <a:ext cx="119151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Table 2. </a:t>
            </a:r>
            <a:r>
              <a:rPr lang="en-US" sz="1400" b="1" dirty="0" err="1"/>
              <a:t>Quickscore</a:t>
            </a:r>
            <a:r>
              <a:rPr lang="en-US" sz="1400" b="1" dirty="0"/>
              <a:t> intensity and proportion criteria.</a:t>
            </a:r>
            <a:endParaRPr lang="en-GB" sz="1400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25567442"/>
              </p:ext>
            </p:extLst>
          </p:nvPr>
        </p:nvGraphicFramePr>
        <p:xfrm>
          <a:off x="4876800" y="866774"/>
          <a:ext cx="2593975" cy="31089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593975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</a:tblGrid>
              <a:tr h="204814">
                <a:tc>
                  <a:txBody>
                    <a:bodyPr/>
                    <a:lstStyle/>
                    <a:p>
                      <a:pPr algn="ctr"/>
                      <a:r>
                        <a:rPr lang="en-GB" sz="1100" b="1" dirty="0"/>
                        <a:t>Intensity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04814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/>
                        <a:t>0</a:t>
                      </a:r>
                      <a:r>
                        <a:rPr lang="en-GB" sz="1100" baseline="0" dirty="0"/>
                        <a:t> = No Staining</a:t>
                      </a:r>
                      <a:endParaRPr lang="en-GB" sz="11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04814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/>
                        <a:t>1 = Light Staining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04814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/>
                        <a:t>2 = Moderate Staining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04814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/>
                        <a:t>3 =</a:t>
                      </a:r>
                      <a:r>
                        <a:rPr lang="en-GB" sz="1100" baseline="0" dirty="0"/>
                        <a:t> Strong Staining</a:t>
                      </a:r>
                      <a:endParaRPr lang="en-GB" sz="1100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04814">
                <a:tc>
                  <a:txBody>
                    <a:bodyPr/>
                    <a:lstStyle/>
                    <a:p>
                      <a:pPr algn="ctr"/>
                      <a:r>
                        <a:rPr lang="en-GB" sz="1100" b="1" dirty="0"/>
                        <a:t>Proportion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04814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/>
                        <a:t>1 = 0-4%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04814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/>
                        <a:t>2 = 5-20%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204814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/>
                        <a:t>3 = 21-40%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204814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/>
                        <a:t>4 = 41-60%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204814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/>
                        <a:t>5 = 61-80%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204814">
                <a:tc>
                  <a:txBody>
                    <a:bodyPr/>
                    <a:lstStyle/>
                    <a:p>
                      <a:pPr algn="ctr"/>
                      <a:r>
                        <a:rPr lang="en-GB" sz="1100" dirty="0"/>
                        <a:t>6 = 81-100%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769971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76809" y="202631"/>
            <a:ext cx="1191519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Table </a:t>
            </a:r>
            <a:r>
              <a:rPr lang="en-US" sz="1400" b="1" dirty="0"/>
              <a:t>3</a:t>
            </a:r>
            <a:r>
              <a:rPr lang="en-US" sz="1400" b="1" dirty="0" smtClean="0"/>
              <a:t>. </a:t>
            </a:r>
            <a:r>
              <a:rPr lang="en-GB" sz="1400" b="1" dirty="0" smtClean="0"/>
              <a:t>Summary of Univariate and Multivariate analysis for overall survival</a:t>
            </a:r>
            <a:r>
              <a:rPr lang="en-GB" sz="1400" dirty="0" smtClean="0"/>
              <a:t>. </a:t>
            </a:r>
            <a:r>
              <a:rPr lang="en-GB" sz="1400" dirty="0"/>
              <a:t>Variable screening for both clinical risk factors </a:t>
            </a:r>
            <a:r>
              <a:rPr lang="en-GB" sz="1400" dirty="0" smtClean="0"/>
              <a:t>and </a:t>
            </a:r>
            <a:r>
              <a:rPr lang="en-GB" sz="1400" dirty="0"/>
              <a:t>microRNAs was performed using univariate Cox regression analyses. Variables considered as associated with outcome (p&lt;0.2) were entered as candidates in a stepwise multivariate </a:t>
            </a:r>
            <a:r>
              <a:rPr lang="en-GB" sz="1400" dirty="0" smtClean="0"/>
              <a:t>analysis. Relationship=sibling/matched </a:t>
            </a:r>
            <a:r>
              <a:rPr lang="en-GB" sz="1400" dirty="0"/>
              <a:t>u</a:t>
            </a:r>
            <a:r>
              <a:rPr lang="en-GB" sz="1400" dirty="0" smtClean="0"/>
              <a:t>nrelated </a:t>
            </a:r>
            <a:r>
              <a:rPr lang="en-GB" sz="1400" dirty="0"/>
              <a:t>d</a:t>
            </a:r>
            <a:r>
              <a:rPr lang="en-GB" sz="1400" dirty="0" smtClean="0"/>
              <a:t>onor; CMV=Cytomegalovirus; Regimen=</a:t>
            </a:r>
            <a:r>
              <a:rPr lang="en-GB" sz="1400" dirty="0" err="1" smtClean="0"/>
              <a:t>myeloablative</a:t>
            </a:r>
            <a:r>
              <a:rPr lang="en-GB" sz="1400" dirty="0" smtClean="0"/>
              <a:t>/reduced intensity conditioning; HR=hazard ratio; CI=confidence interval.</a:t>
            </a:r>
            <a:endParaRPr lang="en-GB" sz="1400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46798408"/>
              </p:ext>
            </p:extLst>
          </p:nvPr>
        </p:nvGraphicFramePr>
        <p:xfrm>
          <a:off x="1930716" y="1476285"/>
          <a:ext cx="8028615" cy="4572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43581"/>
                <a:gridCol w="2005790"/>
                <a:gridCol w="1459748"/>
                <a:gridCol w="1459748"/>
                <a:gridCol w="1459748"/>
              </a:tblGrid>
              <a:tr h="224837">
                <a:tc>
                  <a:txBody>
                    <a:bodyPr/>
                    <a:lstStyle/>
                    <a:p>
                      <a:endParaRPr lang="en-GB" sz="14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400" b="1" dirty="0" smtClean="0"/>
                        <a:t>Univariate Analysis</a:t>
                      </a:r>
                      <a:endParaRPr lang="en-GB" sz="1400" b="1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400" b="1" dirty="0" smtClean="0"/>
                        <a:t>Multivariate Analysis</a:t>
                      </a:r>
                      <a:endParaRPr lang="en-GB" sz="1400" b="1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</a:tr>
              <a:tr h="224837"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 smtClean="0"/>
                        <a:t>Factor</a:t>
                      </a:r>
                      <a:endParaRPr lang="en-GB" sz="1400" b="1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 smtClean="0"/>
                        <a:t>HR (95% CI)</a:t>
                      </a:r>
                      <a:endParaRPr lang="en-GB" sz="1400" b="1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 smtClean="0"/>
                        <a:t>P-value</a:t>
                      </a:r>
                      <a:endParaRPr lang="en-GB" sz="1400" b="1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 smtClean="0"/>
                        <a:t>HR (95% CI)</a:t>
                      </a:r>
                      <a:endParaRPr lang="en-GB" sz="1400" b="1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b="1" dirty="0" smtClean="0"/>
                        <a:t>P-value</a:t>
                      </a:r>
                      <a:endParaRPr lang="en-GB" sz="1400" b="1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4837">
                <a:tc>
                  <a:txBody>
                    <a:bodyPr/>
                    <a:lstStyle/>
                    <a:p>
                      <a:r>
                        <a:rPr lang="en-GB" sz="1400" dirty="0" smtClean="0"/>
                        <a:t>Patient Age</a:t>
                      </a:r>
                      <a:endParaRPr lang="en-GB" sz="14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1.009</a:t>
                      </a:r>
                      <a:r>
                        <a:rPr lang="en-GB" sz="1400" baseline="0" dirty="0" smtClean="0"/>
                        <a:t> (0.959-1.061</a:t>
                      </a:r>
                      <a:endParaRPr lang="en-GB" sz="14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0.729</a:t>
                      </a:r>
                      <a:endParaRPr lang="en-GB" sz="14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N/I</a:t>
                      </a:r>
                      <a:endParaRPr lang="en-GB" sz="14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N/I</a:t>
                      </a:r>
                      <a:endParaRPr lang="en-GB" sz="14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24837">
                <a:tc>
                  <a:txBody>
                    <a:bodyPr/>
                    <a:lstStyle/>
                    <a:p>
                      <a:r>
                        <a:rPr lang="en-GB" sz="1400" dirty="0" smtClean="0"/>
                        <a:t>Relationship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0.726 (0.146-3.60)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0.695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N/I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N/I</a:t>
                      </a:r>
                      <a:endParaRPr lang="en-GB" sz="1400" dirty="0"/>
                    </a:p>
                  </a:txBody>
                  <a:tcPr/>
                </a:tc>
              </a:tr>
              <a:tr h="224837">
                <a:tc>
                  <a:txBody>
                    <a:bodyPr/>
                    <a:lstStyle/>
                    <a:p>
                      <a:r>
                        <a:rPr lang="en-GB" sz="1400" dirty="0" smtClean="0"/>
                        <a:t>Patient Gender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29.82 (0.022-40381.8)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0.356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N/I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N/I</a:t>
                      </a:r>
                      <a:endParaRPr lang="en-GB" sz="1400" dirty="0"/>
                    </a:p>
                  </a:txBody>
                  <a:tcPr/>
                </a:tc>
              </a:tr>
              <a:tr h="224837">
                <a:tc>
                  <a:txBody>
                    <a:bodyPr/>
                    <a:lstStyle/>
                    <a:p>
                      <a:r>
                        <a:rPr lang="en-GB" sz="1400" dirty="0" smtClean="0"/>
                        <a:t>Patient</a:t>
                      </a:r>
                      <a:r>
                        <a:rPr lang="en-GB" sz="1400" baseline="0" dirty="0" smtClean="0"/>
                        <a:t> CMV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0.353</a:t>
                      </a:r>
                      <a:r>
                        <a:rPr lang="en-GB" sz="1400" baseline="0" dirty="0" smtClean="0"/>
                        <a:t> (0.09-1.44)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0.146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N/A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0.374</a:t>
                      </a:r>
                      <a:endParaRPr lang="en-GB" sz="1400" dirty="0"/>
                    </a:p>
                  </a:txBody>
                  <a:tcPr/>
                </a:tc>
              </a:tr>
              <a:tr h="224837">
                <a:tc>
                  <a:txBody>
                    <a:bodyPr/>
                    <a:lstStyle/>
                    <a:p>
                      <a:r>
                        <a:rPr lang="en-GB" sz="1400" dirty="0" smtClean="0"/>
                        <a:t>Donor CMV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0.745 (0.177-3.13)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0.688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N/I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N/I</a:t>
                      </a:r>
                      <a:endParaRPr lang="en-GB" sz="1400" dirty="0"/>
                    </a:p>
                  </a:txBody>
                  <a:tcPr/>
                </a:tc>
              </a:tr>
              <a:tr h="224837">
                <a:tc>
                  <a:txBody>
                    <a:bodyPr/>
                    <a:lstStyle/>
                    <a:p>
                      <a:r>
                        <a:rPr lang="en-GB" sz="1400" dirty="0" smtClean="0"/>
                        <a:t>Regimen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0.547 (0.067-4.459)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0.573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N/I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N/I</a:t>
                      </a:r>
                      <a:endParaRPr lang="en-GB" sz="1400" dirty="0"/>
                    </a:p>
                  </a:txBody>
                  <a:tcPr/>
                </a:tc>
              </a:tr>
              <a:tr h="224837">
                <a:tc>
                  <a:txBody>
                    <a:bodyPr/>
                    <a:lstStyle/>
                    <a:p>
                      <a:r>
                        <a:rPr lang="en-GB" sz="1400" dirty="0" smtClean="0"/>
                        <a:t>aGvHD</a:t>
                      </a:r>
                      <a:r>
                        <a:rPr lang="en-GB" sz="1400" baseline="0" dirty="0" smtClean="0"/>
                        <a:t> stage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3.184 (0.755-13.440)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0.115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N/A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0.680</a:t>
                      </a:r>
                      <a:endParaRPr lang="en-GB" sz="1400" dirty="0"/>
                    </a:p>
                  </a:txBody>
                  <a:tcPr/>
                </a:tc>
              </a:tr>
              <a:tr h="224837">
                <a:tc>
                  <a:txBody>
                    <a:bodyPr/>
                    <a:lstStyle/>
                    <a:p>
                      <a:r>
                        <a:rPr lang="en-GB" sz="1400" dirty="0" smtClean="0"/>
                        <a:t>HLA Mismatch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2.545 (0.636-10.18)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0.187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N/A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0.588</a:t>
                      </a:r>
                      <a:endParaRPr lang="en-GB" sz="1400" dirty="0"/>
                    </a:p>
                  </a:txBody>
                  <a:tcPr/>
                </a:tc>
              </a:tr>
              <a:tr h="224837">
                <a:tc>
                  <a:txBody>
                    <a:bodyPr/>
                    <a:lstStyle/>
                    <a:p>
                      <a:r>
                        <a:rPr lang="en-GB" sz="1400" dirty="0" smtClean="0"/>
                        <a:t>Diagnosis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0.951 (0.632-1.432)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0.810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N/I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N/I</a:t>
                      </a:r>
                      <a:endParaRPr lang="en-GB" sz="1400" dirty="0"/>
                    </a:p>
                  </a:txBody>
                  <a:tcPr/>
                </a:tc>
              </a:tr>
              <a:tr h="224837">
                <a:tc>
                  <a:txBody>
                    <a:bodyPr/>
                    <a:lstStyle/>
                    <a:p>
                      <a:r>
                        <a:rPr lang="en-GB" sz="1400" dirty="0" smtClean="0"/>
                        <a:t>Let-7c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1.42 (0.17-11.54)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0.745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N/I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N/I</a:t>
                      </a:r>
                      <a:endParaRPr lang="en-GB" sz="1400" dirty="0"/>
                    </a:p>
                  </a:txBody>
                  <a:tcPr/>
                </a:tc>
              </a:tr>
              <a:tr h="224837">
                <a:tc>
                  <a:txBody>
                    <a:bodyPr/>
                    <a:lstStyle/>
                    <a:p>
                      <a:r>
                        <a:rPr lang="en-GB" sz="1400" dirty="0" smtClean="0"/>
                        <a:t>miR-34a-3p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10.93 (1.32-90.31)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0.026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N/A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0.081</a:t>
                      </a:r>
                      <a:endParaRPr lang="en-GB" sz="1400" dirty="0"/>
                    </a:p>
                  </a:txBody>
                  <a:tcPr/>
                </a:tc>
              </a:tr>
              <a:tr h="224837">
                <a:tc>
                  <a:txBody>
                    <a:bodyPr/>
                    <a:lstStyle/>
                    <a:p>
                      <a:r>
                        <a:rPr lang="en-GB" sz="1400" dirty="0" smtClean="0"/>
                        <a:t>miR-34a-5p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1.33 (0.16-10.86)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0.789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N/I</a:t>
                      </a:r>
                      <a:endParaRPr lang="en-GB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N/I</a:t>
                      </a:r>
                      <a:endParaRPr lang="en-GB" sz="1400" dirty="0"/>
                    </a:p>
                  </a:txBody>
                  <a:tcPr/>
                </a:tc>
              </a:tr>
              <a:tr h="224837">
                <a:tc>
                  <a:txBody>
                    <a:bodyPr/>
                    <a:lstStyle/>
                    <a:p>
                      <a:r>
                        <a:rPr lang="en-GB" sz="1400" dirty="0" smtClean="0"/>
                        <a:t>miR-503-5p</a:t>
                      </a:r>
                      <a:endParaRPr lang="en-GB" sz="14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7.66 (1.51-38.95)</a:t>
                      </a:r>
                      <a:endParaRPr lang="en-GB" sz="14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0.014</a:t>
                      </a:r>
                      <a:endParaRPr lang="en-GB" sz="14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6.87 (1.35-34.89)</a:t>
                      </a:r>
                      <a:endParaRPr lang="en-GB" sz="14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400" dirty="0" smtClean="0"/>
                        <a:t>0.020</a:t>
                      </a:r>
                      <a:endParaRPr lang="en-GB" sz="14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206163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34079" y="252225"/>
            <a:ext cx="1154654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1. MicroRNA expression in the discovery cohort controls and skin aGvHD samples, according to histopathological stage</a:t>
            </a:r>
            <a:r>
              <a:rPr lang="en-US" sz="1400" dirty="0"/>
              <a:t>. </a:t>
            </a:r>
            <a:r>
              <a:rPr lang="en-US" sz="1400" dirty="0" err="1"/>
              <a:t>Normalised</a:t>
            </a:r>
            <a:r>
              <a:rPr lang="en-US" sz="1400" dirty="0"/>
              <a:t> microRNA expression results were log</a:t>
            </a:r>
            <a:r>
              <a:rPr lang="en-US" sz="1400" baseline="-25000" dirty="0"/>
              <a:t>2</a:t>
            </a:r>
            <a:r>
              <a:rPr lang="en-US" sz="1400" dirty="0"/>
              <a:t> transformed. Each bar represents mean with SEM. </a:t>
            </a:r>
            <a:r>
              <a:rPr lang="en-GB" sz="1400" dirty="0"/>
              <a:t>Differences in microRNA expression across groups were calculated using one-way ANOVA. Significance was set at </a:t>
            </a:r>
            <a:r>
              <a:rPr lang="en-US" sz="1400" dirty="0"/>
              <a:t>p≤0.05 (*).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638674" y="1254839"/>
            <a:ext cx="11287649" cy="3921779"/>
            <a:chOff x="774140" y="560573"/>
            <a:chExt cx="11287649" cy="3921779"/>
          </a:xfrm>
        </p:grpSpPr>
        <p:grpSp>
          <p:nvGrpSpPr>
            <p:cNvPr id="24" name="Group 23"/>
            <p:cNvGrpSpPr/>
            <p:nvPr/>
          </p:nvGrpSpPr>
          <p:grpSpPr>
            <a:xfrm>
              <a:off x="774140" y="560573"/>
              <a:ext cx="11176390" cy="3921779"/>
              <a:chOff x="774140" y="560573"/>
              <a:chExt cx="11176390" cy="3921779"/>
            </a:xfrm>
          </p:grpSpPr>
          <p:pic>
            <p:nvPicPr>
              <p:cNvPr id="1026" name="Picture 25" descr="Discriminatory graph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74140" y="560573"/>
                <a:ext cx="11176390" cy="39217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3" name="TextBox 2"/>
              <p:cNvSpPr txBox="1"/>
              <p:nvPr/>
            </p:nvSpPr>
            <p:spPr>
              <a:xfrm>
                <a:off x="4249272" y="1582556"/>
                <a:ext cx="48409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b="1" dirty="0"/>
                  <a:t>*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2178422" y="1394292"/>
                <a:ext cx="48409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b="1" dirty="0"/>
                  <a:t>*</a:t>
                </a: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3227293" y="3052758"/>
                <a:ext cx="48409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b="1" dirty="0"/>
                  <a:t>*</a:t>
                </a: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5280211" y="1143288"/>
                <a:ext cx="48409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b="1" dirty="0"/>
                  <a:t>*</a:t>
                </a: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6311154" y="1492910"/>
                <a:ext cx="48409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b="1" dirty="0"/>
                  <a:t>*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7342097" y="1179148"/>
                <a:ext cx="48409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b="1" dirty="0"/>
                  <a:t>*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8390965" y="990889"/>
                <a:ext cx="48409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b="1" dirty="0"/>
                  <a:t>*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9439832" y="2864512"/>
                <a:ext cx="48409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b="1" dirty="0"/>
                  <a:t>*</a:t>
                </a:r>
              </a:p>
            </p:txBody>
          </p:sp>
        </p:grpSp>
        <p:sp>
          <p:nvSpPr>
            <p:cNvPr id="4" name="TextBox 3"/>
            <p:cNvSpPr txBox="1"/>
            <p:nvPr/>
          </p:nvSpPr>
          <p:spPr>
            <a:xfrm>
              <a:off x="10781629" y="1258936"/>
              <a:ext cx="1280160" cy="93871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Normal</a:t>
              </a:r>
            </a:p>
            <a:p>
              <a:endParaRPr lang="en-GB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tage 1</a:t>
              </a:r>
            </a:p>
            <a:p>
              <a:endParaRPr lang="en-GB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tage 2-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809515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76809" y="709802"/>
            <a:ext cx="1191519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2. MiR-34a-5p expression positively correlated with miR-34a-3p expression in skin biopsies. </a:t>
            </a:r>
            <a:r>
              <a:rPr lang="en-US" sz="1400" dirty="0"/>
              <a:t>There was a direct positive correlation between</a:t>
            </a:r>
            <a:r>
              <a:rPr lang="en-US" sz="1400" b="1" dirty="0"/>
              <a:t> </a:t>
            </a:r>
            <a:r>
              <a:rPr lang="en-US" sz="1400" dirty="0"/>
              <a:t>miR-34a-3p and miR-34a-5p expression in the validation cohort, as assessed using Spearman correlation. Spearman’s rho: </a:t>
            </a:r>
            <a:r>
              <a:rPr lang="en-US" sz="1400" dirty="0" err="1"/>
              <a:t>r</a:t>
            </a:r>
            <a:r>
              <a:rPr lang="en-US" sz="1400" baseline="-25000" dirty="0" err="1"/>
              <a:t>s</a:t>
            </a:r>
            <a:r>
              <a:rPr lang="en-US" sz="1400" dirty="0"/>
              <a:t>. Solid line represents regression. </a:t>
            </a:r>
            <a:endParaRPr lang="en-GB" sz="1400" dirty="0"/>
          </a:p>
          <a:p>
            <a:r>
              <a:rPr lang="en-US" sz="1400" dirty="0"/>
              <a:t> </a:t>
            </a:r>
            <a:endParaRPr lang="en-GB" sz="1400" dirty="0"/>
          </a:p>
          <a:p>
            <a:endParaRPr lang="en-GB" sz="1400" dirty="0">
              <a:solidFill>
                <a:srgbClr val="FF0000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52887" y="1738312"/>
            <a:ext cx="4086225" cy="3381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758859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6612" y="5739002"/>
            <a:ext cx="1191519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3. Rotational 3D scatterplots demonstrating miR-503-5p and miR-34a-3p conditional interaction. </a:t>
            </a:r>
            <a:r>
              <a:rPr lang="en-US" sz="1200" dirty="0"/>
              <a:t>In the validation cohort, (A) higher miR-503-5p expression was associated with skin histopathological aGvHD severity, (B) lower miR-34a-3p expression was also associated with skin aGvHD severity and (C) distinct separation between the deceased and surviving patients based on their microRNA expression levels, in particular with low miR-34a-3p expression, showing improved OS. The plot shows three axes: miR-34a-3p, miR-503-5p and cutaneous histopathological aGvHD stage. Red=deceased, blue= surviving patients. Each dot represents a patient. Non-parametric density contours were drawn based on the patient survival status (deceased or alive). The arrow shows the expression scale from high to low.</a:t>
            </a:r>
            <a:endParaRPr lang="en-GB" sz="1200" dirty="0"/>
          </a:p>
        </p:txBody>
      </p:sp>
      <p:pic>
        <p:nvPicPr>
          <p:cNvPr id="1026" name="Picture 10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46123" y="125307"/>
            <a:ext cx="6179261" cy="56136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51973136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6612" y="5739002"/>
            <a:ext cx="1191519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4. p53 expression in the epidermis. </a:t>
            </a:r>
            <a:r>
              <a:rPr lang="en-US" sz="1400" dirty="0"/>
              <a:t>(A) Correlation between the proportion of cells positively staining for p53 and miR-34a-5p expression in the epidermis of clinical skin biopsies (n=22). Spearman correlation was used to calculate the coefficient of correlation (rho) = </a:t>
            </a:r>
            <a:r>
              <a:rPr lang="en-US" sz="1400" dirty="0" err="1"/>
              <a:t>r</a:t>
            </a:r>
            <a:r>
              <a:rPr lang="en-US" sz="1400" baseline="-25000" dirty="0" err="1"/>
              <a:t>s</a:t>
            </a:r>
            <a:r>
              <a:rPr lang="en-US" sz="1400" dirty="0"/>
              <a:t>. (B) p53 expression in the epidermis of skin biopsies, in relation to pre-</a:t>
            </a:r>
            <a:r>
              <a:rPr lang="en-US" sz="1400" dirty="0" err="1"/>
              <a:t>Tx</a:t>
            </a:r>
            <a:r>
              <a:rPr lang="en-US" sz="1400" dirty="0"/>
              <a:t> samples and skin aGvHD stage. </a:t>
            </a:r>
            <a:r>
              <a:rPr lang="en-US" sz="1400" dirty="0" err="1"/>
              <a:t>Kruskal</a:t>
            </a:r>
            <a:r>
              <a:rPr lang="en-US" sz="1400" dirty="0"/>
              <a:t>-Wallis analysis of variance was performed to determine the difference between the three groups. Significance was set at p&lt;0.05.</a:t>
            </a:r>
            <a:endParaRPr lang="en-GB" sz="1400" dirty="0">
              <a:solidFill>
                <a:srgbClr val="FF0000"/>
              </a:solidFill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5382" y="1056322"/>
            <a:ext cx="9750112" cy="4190048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814548" y="1125886"/>
            <a:ext cx="34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853398" y="1129696"/>
            <a:ext cx="340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5507356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763</TotalTime>
  <Words>633</Words>
  <Application>Microsoft Office PowerPoint</Application>
  <PresentationFormat>Widescreen</PresentationFormat>
  <Paragraphs>129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ewcastle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chel Crossland</dc:creator>
  <cp:lastModifiedBy>Rachel Crossland</cp:lastModifiedBy>
  <cp:revision>154</cp:revision>
  <cp:lastPrinted>2018-01-15T09:04:10Z</cp:lastPrinted>
  <dcterms:created xsi:type="dcterms:W3CDTF">2017-07-13T13:22:46Z</dcterms:created>
  <dcterms:modified xsi:type="dcterms:W3CDTF">2018-06-13T11:21:40Z</dcterms:modified>
</cp:coreProperties>
</file>